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805"/>
    <p:restoredTop sz="99306" autoAdjust="0"/>
  </p:normalViewPr>
  <p:slideViewPr>
    <p:cSldViewPr snapToGrid="0">
      <p:cViewPr varScale="1">
        <p:scale>
          <a:sx n="131" d="100"/>
          <a:sy n="131" d="100"/>
        </p:scale>
        <p:origin x="176" y="7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Volumes/group09/Carrie/Breast%20Cancer%20project/Carrie's%20Data/qRT-PCR/all%20qRT-PCR%20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Volumes/group09/Carrie/Breast%20Cancer%20project/Carrie's%20Data/CHiP-PCR/final%20summar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Volumes/group09/Carrie/Breast%20Cancer%20project/Carrie's%20Data/qRT-PCR/qRT-PCR%20Summary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//Volumes/group09/Carrie/Breast%20Cancer%20project/Carrie's%20Data/CHiP-PCR/final%20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MDA231</a:t>
            </a:r>
          </a:p>
        </c:rich>
      </c:tx>
      <c:layout>
        <c:manualLayout>
          <c:xMode val="edge"/>
          <c:yMode val="edge"/>
          <c:x val="0.49274623731667"/>
          <c:y val="0.094983807878420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DA231'!$F$14:$F$17</c:f>
                <c:numCache>
                  <c:formatCode>General</c:formatCode>
                  <c:ptCount val="4"/>
                  <c:pt idx="0">
                    <c:v>0.222233559801488</c:v>
                  </c:pt>
                  <c:pt idx="1">
                    <c:v>0.198626611676085</c:v>
                  </c:pt>
                  <c:pt idx="2">
                    <c:v>0.208459959137455</c:v>
                  </c:pt>
                  <c:pt idx="3">
                    <c:v>0.0841155639676729</c:v>
                  </c:pt>
                </c:numCache>
              </c:numRef>
            </c:plus>
            <c:minus>
              <c:numRef>
                <c:f>'MDA231'!$F$14:$F$17</c:f>
                <c:numCache>
                  <c:formatCode>General</c:formatCode>
                  <c:ptCount val="4"/>
                  <c:pt idx="0">
                    <c:v>0.222233559801488</c:v>
                  </c:pt>
                  <c:pt idx="1">
                    <c:v>0.198626611676085</c:v>
                  </c:pt>
                  <c:pt idx="2">
                    <c:v>0.208459959137455</c:v>
                  </c:pt>
                  <c:pt idx="3">
                    <c:v>0.08411556396767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DA231'!$A$14:$A$17</c:f>
              <c:strCache>
                <c:ptCount val="4"/>
                <c:pt idx="0">
                  <c:v>RelB</c:v>
                </c:pt>
                <c:pt idx="1">
                  <c:v>p52</c:v>
                </c:pt>
                <c:pt idx="2">
                  <c:v>CD44</c:v>
                </c:pt>
                <c:pt idx="3">
                  <c:v>CXCL1</c:v>
                </c:pt>
              </c:strCache>
            </c:strRef>
          </c:cat>
          <c:val>
            <c:numRef>
              <c:f>'MDA231'!$D$14:$D$17</c:f>
              <c:numCache>
                <c:formatCode>General</c:formatCode>
                <c:ptCount val="4"/>
                <c:pt idx="0">
                  <c:v>1.61</c:v>
                </c:pt>
                <c:pt idx="1">
                  <c:v>1.376088969060107</c:v>
                </c:pt>
                <c:pt idx="2">
                  <c:v>1.171759081470901</c:v>
                </c:pt>
                <c:pt idx="3">
                  <c:v>0.7966805000695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70B-0845-9BF4-42633CEB66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28975808"/>
        <c:axId val="-529004288"/>
      </c:barChart>
      <c:catAx>
        <c:axId val="-5289758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529004288"/>
        <c:crosses val="autoZero"/>
        <c:auto val="1"/>
        <c:lblAlgn val="ctr"/>
        <c:lblOffset val="100"/>
        <c:noMultiLvlLbl val="0"/>
      </c:catAx>
      <c:valAx>
        <c:axId val="-529004288"/>
        <c:scaling>
          <c:logBase val="10.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Gene expression fold change (</a:t>
                </a:r>
                <a:r>
                  <a:rPr lang="en-US" dirty="0" err="1"/>
                  <a:t>siIKK</a:t>
                </a:r>
                <a:r>
                  <a:rPr lang="en-US" dirty="0" err="1">
                    <a:latin typeface="Symbol" pitchFamily="2" charset="2"/>
                  </a:rPr>
                  <a:t>e</a:t>
                </a:r>
                <a:r>
                  <a:rPr lang="en-US" dirty="0"/>
                  <a:t>/</a:t>
                </a:r>
                <a:r>
                  <a:rPr lang="en-US" dirty="0" err="1"/>
                  <a:t>siNeg</a:t>
                </a:r>
                <a:r>
                  <a:rPr lang="en-US" dirty="0"/>
                  <a:t>)</a:t>
                </a:r>
              </a:p>
            </c:rich>
          </c:tx>
          <c:layout>
            <c:manualLayout>
              <c:xMode val="edge"/>
              <c:yMode val="edge"/>
              <c:x val="0.0621171529922154"/>
              <c:y val="0.2174376896981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28975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MDA231</a:t>
            </a:r>
          </a:p>
        </c:rich>
      </c:tx>
      <c:layout>
        <c:manualLayout>
          <c:xMode val="edge"/>
          <c:yMode val="edge"/>
          <c:x val="0.465927586348659"/>
          <c:y val="0.05060036642660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75410589568137"/>
          <c:y val="0.148775090727508"/>
          <c:w val="0.668954515524865"/>
          <c:h val="0.702877521380746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1!$K$69</c:f>
              <c:strCache>
                <c:ptCount val="1"/>
                <c:pt idx="0">
                  <c:v>shNeg 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M$70:$M$71</c:f>
                <c:numCache>
                  <c:formatCode>General</c:formatCode>
                  <c:ptCount val="2"/>
                  <c:pt idx="0">
                    <c:v>0.018838991674515</c:v>
                  </c:pt>
                  <c:pt idx="1">
                    <c:v>0.0266485447260598</c:v>
                  </c:pt>
                </c:numCache>
              </c:numRef>
            </c:plus>
            <c:minus>
              <c:numRef>
                <c:f>Sheet1!$M$70:$M$71</c:f>
                <c:numCache>
                  <c:formatCode>General</c:formatCode>
                  <c:ptCount val="2"/>
                  <c:pt idx="0">
                    <c:v>0.018838991674515</c:v>
                  </c:pt>
                  <c:pt idx="1">
                    <c:v>0.02664854472605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I$70:$I$71</c:f>
              <c:numCache>
                <c:formatCode>General</c:formatCode>
                <c:ptCount val="2"/>
                <c:pt idx="0">
                  <c:v>-2.5</c:v>
                </c:pt>
                <c:pt idx="1">
                  <c:v>-0.2</c:v>
                </c:pt>
              </c:numCache>
            </c:numRef>
          </c:cat>
          <c:val>
            <c:numRef>
              <c:f>Sheet1!$K$70:$K$71</c:f>
              <c:numCache>
                <c:formatCode>General</c:formatCode>
                <c:ptCount val="2"/>
                <c:pt idx="0">
                  <c:v>0.8175408046573</c:v>
                </c:pt>
                <c:pt idx="1">
                  <c:v>0.6279490693750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849-2A48-86F8-69E6493A5830}"/>
            </c:ext>
          </c:extLst>
        </c:ser>
        <c:ser>
          <c:idx val="0"/>
          <c:order val="1"/>
          <c:tx>
            <c:strRef>
              <c:f>Sheet1!$J$69</c:f>
              <c:strCache>
                <c:ptCount val="1"/>
                <c:pt idx="0">
                  <c:v>shIKKe 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70:$L$71</c:f>
                <c:numCache>
                  <c:formatCode>General</c:formatCode>
                  <c:ptCount val="2"/>
                  <c:pt idx="0">
                    <c:v>0.0197592713629576</c:v>
                  </c:pt>
                  <c:pt idx="1">
                    <c:v>0.0264964896404043</c:v>
                  </c:pt>
                </c:numCache>
              </c:numRef>
            </c:plus>
            <c:minus>
              <c:numRef>
                <c:f>Sheet1!$L$70:$L$71</c:f>
                <c:numCache>
                  <c:formatCode>General</c:formatCode>
                  <c:ptCount val="2"/>
                  <c:pt idx="0">
                    <c:v>0.0197592713629576</c:v>
                  </c:pt>
                  <c:pt idx="1">
                    <c:v>0.02649648964040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I$70:$I$71</c:f>
              <c:numCache>
                <c:formatCode>General</c:formatCode>
                <c:ptCount val="2"/>
                <c:pt idx="0">
                  <c:v>-2.5</c:v>
                </c:pt>
                <c:pt idx="1">
                  <c:v>-0.2</c:v>
                </c:pt>
              </c:numCache>
            </c:numRef>
          </c:cat>
          <c:val>
            <c:numRef>
              <c:f>Sheet1!$J$70:$J$71</c:f>
              <c:numCache>
                <c:formatCode>General</c:formatCode>
                <c:ptCount val="2"/>
                <c:pt idx="0">
                  <c:v>1.28064312631075</c:v>
                </c:pt>
                <c:pt idx="1">
                  <c:v>1.9496297428948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849-2A48-86F8-69E6493A58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29162224"/>
        <c:axId val="-529178400"/>
      </c:barChart>
      <c:catAx>
        <c:axId val="-529162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29178400"/>
        <c:crosses val="autoZero"/>
        <c:auto val="1"/>
        <c:lblAlgn val="ctr"/>
        <c:lblOffset val="100"/>
        <c:noMultiLvlLbl val="0"/>
      </c:catAx>
      <c:valAx>
        <c:axId val="-529178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52 binding enrichment on CXCL1 promoter relative to negative control</a:t>
                </a:r>
              </a:p>
            </c:rich>
          </c:tx>
          <c:layout>
            <c:manualLayout>
              <c:xMode val="edge"/>
              <c:yMode val="edge"/>
              <c:x val="0.0161816332733739"/>
              <c:y val="0.1446853197265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29162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MDA231</a:t>
            </a:r>
          </a:p>
        </c:rich>
      </c:tx>
      <c:layout>
        <c:manualLayout>
          <c:xMode val="edge"/>
          <c:yMode val="edge"/>
          <c:x val="0.48775477764987"/>
          <c:y val="0.038869288218535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96618322983976"/>
          <c:y val="0.183336810058923"/>
          <c:w val="0.645577925479025"/>
          <c:h val="0.7206753312714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DA231'!$G$5:$G$7</c:f>
                <c:numCache>
                  <c:formatCode>General</c:formatCode>
                  <c:ptCount val="3"/>
                  <c:pt idx="0">
                    <c:v>0.0380411639563215</c:v>
                  </c:pt>
                  <c:pt idx="1">
                    <c:v>0.0269889089079157</c:v>
                  </c:pt>
                  <c:pt idx="2">
                    <c:v>0.00798018021121667</c:v>
                  </c:pt>
                </c:numCache>
              </c:numRef>
            </c:plus>
            <c:minus>
              <c:numRef>
                <c:f>'MDA231'!$G$5:$G$7</c:f>
                <c:numCache>
                  <c:formatCode>General</c:formatCode>
                  <c:ptCount val="3"/>
                  <c:pt idx="0">
                    <c:v>0.0380411639563215</c:v>
                  </c:pt>
                  <c:pt idx="1">
                    <c:v>0.0269889089079157</c:v>
                  </c:pt>
                  <c:pt idx="2">
                    <c:v>0.007980180211216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DA231'!$A$5:$A$7</c:f>
              <c:strCache>
                <c:ptCount val="3"/>
                <c:pt idx="0">
                  <c:v>p52</c:v>
                </c:pt>
                <c:pt idx="1">
                  <c:v>CD44</c:v>
                </c:pt>
                <c:pt idx="2">
                  <c:v>CXCL1</c:v>
                </c:pt>
              </c:strCache>
            </c:strRef>
          </c:cat>
          <c:val>
            <c:numRef>
              <c:f>'MDA231'!$E$5:$E$7</c:f>
              <c:numCache>
                <c:formatCode>General</c:formatCode>
                <c:ptCount val="3"/>
                <c:pt idx="0">
                  <c:v>0.161802933013571</c:v>
                </c:pt>
                <c:pt idx="1">
                  <c:v>1.051985807207408</c:v>
                </c:pt>
                <c:pt idx="2">
                  <c:v>0.880491779095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3CE-F642-9F9D-1DB2D1ADED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29378608"/>
        <c:axId val="-529530144"/>
      </c:barChart>
      <c:catAx>
        <c:axId val="-5293786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529530144"/>
        <c:crosses val="autoZero"/>
        <c:auto val="1"/>
        <c:lblAlgn val="ctr"/>
        <c:lblOffset val="100"/>
        <c:noMultiLvlLbl val="0"/>
      </c:catAx>
      <c:valAx>
        <c:axId val="-529530144"/>
        <c:scaling>
          <c:logBase val="10.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Gene expression fold change (sip52/siNeg)</a:t>
                </a:r>
              </a:p>
            </c:rich>
          </c:tx>
          <c:layout>
            <c:manualLayout>
              <c:xMode val="edge"/>
              <c:yMode val="edge"/>
              <c:x val="0.0757071594025102"/>
              <c:y val="0.13468683772156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29378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/>
              <a:t>MDA 468</a:t>
            </a:r>
          </a:p>
        </c:rich>
      </c:tx>
      <c:layout>
        <c:manualLayout>
          <c:xMode val="edge"/>
          <c:yMode val="edge"/>
          <c:x val="0.491345814654695"/>
          <c:y val="0.047818628837261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520179366424"/>
          <c:y val="0.155167400772048"/>
          <c:w val="0.681659036426885"/>
          <c:h val="0.69218036368264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1!$Q$69</c:f>
              <c:strCache>
                <c:ptCount val="1"/>
                <c:pt idx="0">
                  <c:v>shNeg 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S$70:$S$71</c:f>
                <c:numCache>
                  <c:formatCode>General</c:formatCode>
                  <c:ptCount val="2"/>
                  <c:pt idx="0">
                    <c:v>0.0169381474984703</c:v>
                  </c:pt>
                  <c:pt idx="1">
                    <c:v>0.0158749875979581</c:v>
                  </c:pt>
                </c:numCache>
              </c:numRef>
            </c:plus>
            <c:minus>
              <c:numRef>
                <c:f>Sheet1!$S$70:$S$71</c:f>
                <c:numCache>
                  <c:formatCode>General</c:formatCode>
                  <c:ptCount val="2"/>
                  <c:pt idx="0">
                    <c:v>0.0169381474984703</c:v>
                  </c:pt>
                  <c:pt idx="1">
                    <c:v>0.01587498759795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O$70:$O$71</c:f>
              <c:numCache>
                <c:formatCode>General</c:formatCode>
                <c:ptCount val="2"/>
                <c:pt idx="0">
                  <c:v>-2.5</c:v>
                </c:pt>
                <c:pt idx="1">
                  <c:v>-0.2</c:v>
                </c:pt>
              </c:numCache>
            </c:numRef>
          </c:cat>
          <c:val>
            <c:numRef>
              <c:f>Sheet1!$Q$70:$Q$71</c:f>
              <c:numCache>
                <c:formatCode>General</c:formatCode>
                <c:ptCount val="2"/>
                <c:pt idx="0">
                  <c:v>0.496199152024753</c:v>
                </c:pt>
                <c:pt idx="1">
                  <c:v>1.1722806365427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2ED-4C42-A77C-22D0C59AD1AD}"/>
            </c:ext>
          </c:extLst>
        </c:ser>
        <c:ser>
          <c:idx val="0"/>
          <c:order val="1"/>
          <c:tx>
            <c:strRef>
              <c:f>Sheet1!$P$69</c:f>
              <c:strCache>
                <c:ptCount val="1"/>
                <c:pt idx="0">
                  <c:v>shIKKe 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R$70:$R$71</c:f>
                <c:numCache>
                  <c:formatCode>General</c:formatCode>
                  <c:ptCount val="2"/>
                  <c:pt idx="0">
                    <c:v>0.0207266755907196</c:v>
                  </c:pt>
                  <c:pt idx="1">
                    <c:v>0.013791710057621</c:v>
                  </c:pt>
                </c:numCache>
              </c:numRef>
            </c:plus>
            <c:minus>
              <c:numRef>
                <c:f>Sheet1!$R$70:$R$71</c:f>
                <c:numCache>
                  <c:formatCode>General</c:formatCode>
                  <c:ptCount val="2"/>
                  <c:pt idx="0">
                    <c:v>0.0207266755907196</c:v>
                  </c:pt>
                  <c:pt idx="1">
                    <c:v>0.0137917100576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O$70:$O$71</c:f>
              <c:numCache>
                <c:formatCode>General</c:formatCode>
                <c:ptCount val="2"/>
                <c:pt idx="0">
                  <c:v>-2.5</c:v>
                </c:pt>
                <c:pt idx="1">
                  <c:v>-0.2</c:v>
                </c:pt>
              </c:numCache>
            </c:numRef>
          </c:cat>
          <c:val>
            <c:numRef>
              <c:f>Sheet1!$P$70:$P$71</c:f>
              <c:numCache>
                <c:formatCode>General</c:formatCode>
                <c:ptCount val="2"/>
                <c:pt idx="0">
                  <c:v>3.979569611694191</c:v>
                </c:pt>
                <c:pt idx="1">
                  <c:v>3.38290466863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2ED-4C42-A77C-22D0C59AD1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414704160"/>
        <c:axId val="-541097024"/>
      </c:barChart>
      <c:catAx>
        <c:axId val="-41470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41097024"/>
        <c:crosses val="autoZero"/>
        <c:auto val="1"/>
        <c:lblAlgn val="ctr"/>
        <c:lblOffset val="100"/>
        <c:noMultiLvlLbl val="0"/>
      </c:catAx>
      <c:valAx>
        <c:axId val="-5410970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p52 binding enrichment on CXCL1 promoter relative to negative control</a:t>
                </a:r>
              </a:p>
            </c:rich>
          </c:tx>
          <c:layout>
            <c:manualLayout>
              <c:xMode val="edge"/>
              <c:yMode val="edge"/>
              <c:x val="0.0121721207002655"/>
              <c:y val="0.11781375051257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14704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290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15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497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233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843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10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261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25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287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433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3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31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Chart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6232790"/>
              </p:ext>
            </p:extLst>
          </p:nvPr>
        </p:nvGraphicFramePr>
        <p:xfrm>
          <a:off x="2704165" y="705618"/>
          <a:ext cx="4079469" cy="22730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5" name="Straight Connector 4"/>
          <p:cNvCxnSpPr/>
          <p:nvPr/>
        </p:nvCxnSpPr>
        <p:spPr>
          <a:xfrm flipV="1">
            <a:off x="3601149" y="2004237"/>
            <a:ext cx="3033563" cy="158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8194772"/>
              </p:ext>
            </p:extLst>
          </p:nvPr>
        </p:nvGraphicFramePr>
        <p:xfrm>
          <a:off x="0" y="3273390"/>
          <a:ext cx="2967562" cy="22749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7" name="Group 16"/>
          <p:cNvGrpSpPr/>
          <p:nvPr/>
        </p:nvGrpSpPr>
        <p:grpSpPr>
          <a:xfrm>
            <a:off x="-9778" y="874858"/>
            <a:ext cx="2856216" cy="2070554"/>
            <a:chOff x="29071" y="4075782"/>
            <a:chExt cx="2856216" cy="2070554"/>
          </a:xfrm>
        </p:grpSpPr>
        <p:grpSp>
          <p:nvGrpSpPr>
            <p:cNvPr id="16" name="Group 15"/>
            <p:cNvGrpSpPr/>
            <p:nvPr/>
          </p:nvGrpSpPr>
          <p:grpSpPr>
            <a:xfrm>
              <a:off x="29071" y="4075782"/>
              <a:ext cx="2856216" cy="1984626"/>
              <a:chOff x="117055" y="4652734"/>
              <a:chExt cx="2856216" cy="1984626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117055" y="4652734"/>
                <a:ext cx="2856216" cy="1984626"/>
                <a:chOff x="3131598" y="799090"/>
                <a:chExt cx="3229252" cy="1966404"/>
              </a:xfrm>
            </p:grpSpPr>
            <p:graphicFrame>
              <p:nvGraphicFramePr>
                <p:cNvPr id="3" name="Chart 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174862"/>
                    </p:ext>
                  </p:extLst>
                </p:nvPr>
              </p:nvGraphicFramePr>
              <p:xfrm>
                <a:off x="3131598" y="799090"/>
                <a:ext cx="3229252" cy="196640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cxnSp>
              <p:nvCxnSpPr>
                <p:cNvPr id="6" name="Straight Connector 5"/>
                <p:cNvCxnSpPr/>
                <p:nvPr/>
              </p:nvCxnSpPr>
              <p:spPr>
                <a:xfrm>
                  <a:off x="4076087" y="1863449"/>
                  <a:ext cx="2193324" cy="157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" name="TextBox 13"/>
              <p:cNvSpPr txBox="1"/>
              <p:nvPr/>
            </p:nvSpPr>
            <p:spPr>
              <a:xfrm>
                <a:off x="2376341" y="5534586"/>
                <a:ext cx="293933" cy="3101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*</a:t>
                </a: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1055033" y="5836175"/>
              <a:ext cx="293933" cy="310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*</a:t>
              </a: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3292702" y="3273390"/>
            <a:ext cx="3106936" cy="2263072"/>
            <a:chOff x="3396760" y="6427200"/>
            <a:chExt cx="3415393" cy="2376927"/>
          </a:xfrm>
        </p:grpSpPr>
        <p:graphicFrame>
          <p:nvGraphicFramePr>
            <p:cNvPr id="19" name="Chart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96292276"/>
                </p:ext>
              </p:extLst>
            </p:nvPr>
          </p:nvGraphicFramePr>
          <p:xfrm>
            <a:off x="3396760" y="6427200"/>
            <a:ext cx="3415393" cy="23769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0" name="TextBox 19"/>
            <p:cNvSpPr txBox="1"/>
            <p:nvPr/>
          </p:nvSpPr>
          <p:spPr>
            <a:xfrm>
              <a:off x="4904377" y="6694363"/>
              <a:ext cx="285115" cy="3056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*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045003" y="6887865"/>
              <a:ext cx="285115" cy="3056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*</a:t>
              </a: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1185007" y="5374493"/>
            <a:ext cx="1361320" cy="281815"/>
            <a:chOff x="1536582" y="7021625"/>
            <a:chExt cx="1361320" cy="281815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59" t="84672" r="32613" b="7945"/>
            <a:stretch/>
          </p:blipFill>
          <p:spPr>
            <a:xfrm>
              <a:off x="1536582" y="7083777"/>
              <a:ext cx="839729" cy="168763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2306073" y="7026441"/>
              <a:ext cx="5918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shIKK</a:t>
              </a:r>
              <a:r>
                <a:rPr lang="en-US" sz="1200" dirty="0" err="1">
                  <a:latin typeface="Symbol" charset="2"/>
                  <a:cs typeface="Symbol" charset="2"/>
                </a:rPr>
                <a:t>e</a:t>
              </a:r>
              <a:endParaRPr lang="en-US" sz="1200" dirty="0">
                <a:latin typeface="Symbol" charset="2"/>
                <a:cs typeface="Symbol" charset="2"/>
              </a:endParaRP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678461" y="7068265"/>
              <a:ext cx="408883" cy="1842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610507" y="7021625"/>
              <a:ext cx="574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shNeg</a:t>
              </a:r>
              <a:endParaRPr lang="en-US" sz="12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4458422" y="5404703"/>
            <a:ext cx="1476736" cy="281815"/>
            <a:chOff x="1536582" y="7021625"/>
            <a:chExt cx="1476736" cy="281815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59" t="84672" r="32613" b="7945"/>
            <a:stretch/>
          </p:blipFill>
          <p:spPr>
            <a:xfrm>
              <a:off x="1536582" y="7083777"/>
              <a:ext cx="839729" cy="168763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2306073" y="7026441"/>
              <a:ext cx="7072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shIKK</a:t>
              </a:r>
              <a:r>
                <a:rPr lang="en-US" sz="1200" dirty="0" err="1">
                  <a:latin typeface="Symbol" charset="2"/>
                  <a:cs typeface="Symbol" charset="2"/>
                </a:rPr>
                <a:t>e</a:t>
              </a:r>
              <a:r>
                <a:rPr lang="en-US" sz="1200" dirty="0">
                  <a:latin typeface="Symbol" charset="2"/>
                  <a:cs typeface="Symbol" charset="2"/>
                </a:rPr>
                <a:t> </a:t>
              </a:r>
              <a:r>
                <a:rPr lang="en-US" sz="1200" dirty="0">
                  <a:cs typeface="Symbol" charset="2"/>
                </a:rPr>
                <a:t>2</a:t>
              </a: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1678461" y="7068265"/>
              <a:ext cx="408883" cy="1842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610507" y="7021625"/>
              <a:ext cx="68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shNeg</a:t>
              </a:r>
              <a:r>
                <a:rPr lang="en-US" sz="1200" dirty="0"/>
                <a:t> 2</a:t>
              </a:r>
              <a:endParaRPr lang="en-US" sz="1200" dirty="0">
                <a:latin typeface="Symbol" charset="2"/>
                <a:cs typeface="Symbol" charset="2"/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28780" y="711506"/>
            <a:ext cx="282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173571" y="705581"/>
            <a:ext cx="292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4391" y="3043332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304757" y="3652279"/>
            <a:ext cx="259365" cy="2909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308998" y="4047783"/>
            <a:ext cx="259365" cy="2909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787442" y="2824622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FKB2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566873" y="2824622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D44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279612" y="2824622"/>
            <a:ext cx="5668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XCL1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474884" y="2815985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FKB2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254315" y="2815985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D44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967054" y="2815985"/>
            <a:ext cx="5668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XCL1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755932" y="2815985"/>
            <a:ext cx="4609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elB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820972" y="1533304"/>
            <a:ext cx="293933" cy="310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582468" y="1614431"/>
            <a:ext cx="293933" cy="310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173571" y="3043332"/>
            <a:ext cx="292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d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509528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57</TotalTime>
  <Words>64</Words>
  <Application>Microsoft Macintosh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Symbol</vt:lpstr>
      <vt:lpstr>Arial</vt:lpstr>
      <vt:lpstr>Office Theme</vt:lpstr>
      <vt:lpstr>PowerPoint Presentation</vt:lpstr>
    </vt:vector>
  </TitlesOfParts>
  <Company>NIH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Annunziata</dc:creator>
  <cp:lastModifiedBy>Carrie House</cp:lastModifiedBy>
  <cp:revision>359</cp:revision>
  <dcterms:created xsi:type="dcterms:W3CDTF">2016-03-03T15:39:21Z</dcterms:created>
  <dcterms:modified xsi:type="dcterms:W3CDTF">2018-05-09T15:31:50Z</dcterms:modified>
</cp:coreProperties>
</file>